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D6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67" autoAdjust="0"/>
    <p:restoredTop sz="94660"/>
  </p:normalViewPr>
  <p:slideViewPr>
    <p:cSldViewPr snapToGrid="0">
      <p:cViewPr varScale="1">
        <p:scale>
          <a:sx n="47" d="100"/>
          <a:sy n="47" d="100"/>
        </p:scale>
        <p:origin x="1872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hyun\Desktop\190221_Real_time_CF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6</c:f>
              <c:strCache>
                <c:ptCount val="1"/>
                <c:pt idx="0">
                  <c:v>CF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6:$K$6</c:f>
                <c:numCache>
                  <c:formatCode>General</c:formatCode>
                  <c:ptCount val="2"/>
                  <c:pt idx="0">
                    <c:v>6.4665692211401889E-7</c:v>
                  </c:pt>
                  <c:pt idx="1">
                    <c:v>1.1545322075540189E-4</c:v>
                  </c:pt>
                </c:numCache>
              </c:numRef>
            </c:plus>
            <c:minus>
              <c:numRef>
                <c:f>Sheet2!$J$6:$K$6</c:f>
                <c:numCache>
                  <c:formatCode>General</c:formatCode>
                  <c:ptCount val="2"/>
                  <c:pt idx="0">
                    <c:v>6.4665692211401889E-7</c:v>
                  </c:pt>
                  <c:pt idx="1">
                    <c:v>1.1545322075540189E-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6:$I$6</c:f>
              <c:numCache>
                <c:formatCode>General</c:formatCode>
                <c:ptCount val="2"/>
                <c:pt idx="0">
                  <c:v>1.0158848993043847E-6</c:v>
                </c:pt>
                <c:pt idx="1">
                  <c:v>3.394735055890083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06-4FBF-A846-AE4237FEF1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6935759"/>
        <c:axId val="746934511"/>
      </c:barChart>
      <c:catAx>
        <c:axId val="7469357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46934511"/>
        <c:crosses val="autoZero"/>
        <c:auto val="1"/>
        <c:lblAlgn val="ctr"/>
        <c:lblOffset val="100"/>
        <c:noMultiLvlLbl val="0"/>
      </c:catAx>
      <c:valAx>
        <c:axId val="7469345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46935759"/>
        <c:crosses val="autoZero"/>
        <c:crossBetween val="between"/>
        <c:majorUnit val="1.0000000000000002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7</c:f>
              <c:strCache>
                <c:ptCount val="1"/>
                <c:pt idx="0">
                  <c:v>FHL-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7:$K$7</c:f>
                <c:numCache>
                  <c:formatCode>General</c:formatCode>
                  <c:ptCount val="2"/>
                  <c:pt idx="0">
                    <c:v>2.1965896956058351E-5</c:v>
                  </c:pt>
                  <c:pt idx="1">
                    <c:v>6.6417564541642544E-5</c:v>
                  </c:pt>
                </c:numCache>
              </c:numRef>
            </c:plus>
            <c:minus>
              <c:numRef>
                <c:f>Sheet2!$J$7:$K$7</c:f>
                <c:numCache>
                  <c:formatCode>General</c:formatCode>
                  <c:ptCount val="2"/>
                  <c:pt idx="0">
                    <c:v>2.1965896956058351E-5</c:v>
                  </c:pt>
                  <c:pt idx="1">
                    <c:v>6.6417564541642544E-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7:$I$7</c:f>
              <c:numCache>
                <c:formatCode>General</c:formatCode>
                <c:ptCount val="2"/>
                <c:pt idx="0">
                  <c:v>8.84158716063907E-5</c:v>
                </c:pt>
                <c:pt idx="1">
                  <c:v>1.643705889013678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06-473E-8BE2-BE7E6E1495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4561055"/>
        <c:axId val="854561887"/>
      </c:barChart>
      <c:catAx>
        <c:axId val="8545610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54561887"/>
        <c:crosses val="autoZero"/>
        <c:auto val="1"/>
        <c:lblAlgn val="ctr"/>
        <c:lblOffset val="100"/>
        <c:noMultiLvlLbl val="0"/>
      </c:catAx>
      <c:valAx>
        <c:axId val="85456188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54561055"/>
        <c:crosses val="autoZero"/>
        <c:crossBetween val="between"/>
        <c:majorUnit val="5.0000000000000012E-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5</c:f>
              <c:strCache>
                <c:ptCount val="1"/>
                <c:pt idx="0">
                  <c:v>CD59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5:$I$5</c:f>
              <c:numCache>
                <c:formatCode>General</c:formatCode>
                <c:ptCount val="2"/>
                <c:pt idx="0">
                  <c:v>5.8054637567871485E-2</c:v>
                </c:pt>
                <c:pt idx="1">
                  <c:v>9.00076411741556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47-4042-9772-F011A08FE7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09068431"/>
        <c:axId val="709070511"/>
      </c:barChart>
      <c:catAx>
        <c:axId val="70906843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09070511"/>
        <c:crosses val="autoZero"/>
        <c:auto val="1"/>
        <c:lblAlgn val="ctr"/>
        <c:lblOffset val="100"/>
        <c:noMultiLvlLbl val="0"/>
      </c:catAx>
      <c:valAx>
        <c:axId val="70907051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709068431"/>
        <c:crosses val="autoZero"/>
        <c:crossBetween val="between"/>
        <c:majorUnit val="3.0000000000000006E-2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91666666666666"/>
          <c:y val="6.7960692741778558E-2"/>
          <c:w val="0.81942973856209156"/>
          <c:h val="0.786757637672699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G$4</c:f>
              <c:strCache>
                <c:ptCount val="1"/>
                <c:pt idx="0">
                  <c:v>CD55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4:$K$4</c:f>
                <c:numCache>
                  <c:formatCode>General</c:formatCode>
                  <c:ptCount val="2"/>
                  <c:pt idx="0">
                    <c:v>4.4994359879395223E-3</c:v>
                  </c:pt>
                  <c:pt idx="1">
                    <c:v>9.2702723475900529E-4</c:v>
                  </c:pt>
                </c:numCache>
              </c:numRef>
            </c:plus>
            <c:minus>
              <c:numRef>
                <c:f>Sheet2!$J$4:$K$4</c:f>
                <c:numCache>
                  <c:formatCode>General</c:formatCode>
                  <c:ptCount val="2"/>
                  <c:pt idx="0">
                    <c:v>4.4994359879395223E-3</c:v>
                  </c:pt>
                  <c:pt idx="1">
                    <c:v>9.2702723475900529E-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4:$I$4</c:f>
              <c:numCache>
                <c:formatCode>General</c:formatCode>
                <c:ptCount val="2"/>
                <c:pt idx="0">
                  <c:v>0.10840879034952065</c:v>
                </c:pt>
                <c:pt idx="1">
                  <c:v>9.728133275377781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3D-4DCF-B6CA-E8EF7A1CB1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54560639"/>
        <c:axId val="854557727"/>
      </c:barChart>
      <c:catAx>
        <c:axId val="85456063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54557727"/>
        <c:crosses val="autoZero"/>
        <c:auto val="1"/>
        <c:lblAlgn val="ctr"/>
        <c:lblOffset val="100"/>
        <c:noMultiLvlLbl val="0"/>
      </c:catAx>
      <c:valAx>
        <c:axId val="85455772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54560639"/>
        <c:crosses val="autoZero"/>
        <c:crossBetween val="between"/>
        <c:majorUnit val="3.0000000000000006E-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G$3</c:f>
              <c:strCache>
                <c:ptCount val="1"/>
                <c:pt idx="0">
                  <c:v>CD46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3:$K$3</c:f>
                <c:numCache>
                  <c:formatCode>General</c:formatCode>
                  <c:ptCount val="2"/>
                  <c:pt idx="0">
                    <c:v>1.9577757082673637E-3</c:v>
                  </c:pt>
                  <c:pt idx="1">
                    <c:v>1.2323825252611761E-3</c:v>
                  </c:pt>
                </c:numCache>
              </c:numRef>
            </c:plus>
            <c:minus>
              <c:numRef>
                <c:f>Sheet2!$J$3:$K$3</c:f>
                <c:numCache>
                  <c:formatCode>General</c:formatCode>
                  <c:ptCount val="2"/>
                  <c:pt idx="0">
                    <c:v>1.9577757082673637E-3</c:v>
                  </c:pt>
                  <c:pt idx="1">
                    <c:v>1.2323825252611761E-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3:$I$3</c:f>
              <c:numCache>
                <c:formatCode>General</c:formatCode>
                <c:ptCount val="2"/>
                <c:pt idx="0">
                  <c:v>1.4259152515739863E-2</c:v>
                </c:pt>
                <c:pt idx="1">
                  <c:v>7.779097252378144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1A-4A92-8D1A-E884D24BA8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00376783"/>
        <c:axId val="800373455"/>
      </c:barChart>
      <c:catAx>
        <c:axId val="80037678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00373455"/>
        <c:crosses val="autoZero"/>
        <c:auto val="1"/>
        <c:lblAlgn val="ctr"/>
        <c:lblOffset val="100"/>
        <c:noMultiLvlLbl val="0"/>
      </c:catAx>
      <c:valAx>
        <c:axId val="8003734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800376783"/>
        <c:crosses val="autoZero"/>
        <c:crossBetween val="between"/>
        <c:majorUnit val="5.000000000000001E-3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92320261437909"/>
          <c:y val="9.8851916715314264E-2"/>
          <c:w val="0.7364232026143791"/>
          <c:h val="0.786757637672699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G$2</c:f>
              <c:strCache>
                <c:ptCount val="1"/>
                <c:pt idx="0">
                  <c:v>CD35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J$2:$K$2</c:f>
                <c:numCache>
                  <c:formatCode>General</c:formatCode>
                  <c:ptCount val="2"/>
                  <c:pt idx="0">
                    <c:v>9.5629676974674942E-7</c:v>
                  </c:pt>
                  <c:pt idx="1">
                    <c:v>1.3775081985729556E-6</c:v>
                  </c:pt>
                </c:numCache>
              </c:numRef>
            </c:plus>
            <c:minus>
              <c:numRef>
                <c:f>Sheet2!$J$2:$K$2</c:f>
                <c:numCache>
                  <c:formatCode>General</c:formatCode>
                  <c:ptCount val="2"/>
                  <c:pt idx="0">
                    <c:v>9.5629676974674942E-7</c:v>
                  </c:pt>
                  <c:pt idx="1">
                    <c:v>1.3775081985729556E-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H$1:$I$1</c:f>
              <c:strCache>
                <c:ptCount val="2"/>
                <c:pt idx="0">
                  <c:v>L132</c:v>
                </c:pt>
                <c:pt idx="1">
                  <c:v>A549</c:v>
                </c:pt>
              </c:strCache>
            </c:strRef>
          </c:cat>
          <c:val>
            <c:numRef>
              <c:f>Sheet2!$H$2:$I$2</c:f>
              <c:numCache>
                <c:formatCode>General</c:formatCode>
                <c:ptCount val="2"/>
                <c:pt idx="0">
                  <c:v>3.9398390972924659E-6</c:v>
                </c:pt>
                <c:pt idx="1">
                  <c:v>8.2316913763927746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0B-4FAE-B10B-F79AA91B73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3298447"/>
        <c:axId val="593298863"/>
      </c:barChart>
      <c:catAx>
        <c:axId val="5932984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93298863"/>
        <c:crosses val="autoZero"/>
        <c:auto val="1"/>
        <c:lblAlgn val="ctr"/>
        <c:lblOffset val="100"/>
        <c:noMultiLvlLbl val="0"/>
      </c:catAx>
      <c:valAx>
        <c:axId val="59329886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93298447"/>
        <c:crosses val="autoZero"/>
        <c:crossBetween val="between"/>
        <c:majorUnit val="3.0000000000000009E-6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222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0977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6781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3828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112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9940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4277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4885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6199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627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3783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D0EF1-F8E0-47E1-8DE2-58613BCE5626}" type="datetimeFigureOut">
              <a:rPr lang="ko-KR" altLang="en-US" smtClean="0"/>
              <a:t>2019-04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AA7EF-A092-4694-A450-C0CE5AC7AE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3974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9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974892" y="1204220"/>
            <a:ext cx="4832070" cy="6575004"/>
            <a:chOff x="288070" y="262524"/>
            <a:chExt cx="6365052" cy="8660935"/>
          </a:xfrm>
        </p:grpSpPr>
        <p:graphicFrame>
          <p:nvGraphicFramePr>
            <p:cNvPr id="186" name="차트 18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166617"/>
                </p:ext>
              </p:extLst>
            </p:nvPr>
          </p:nvGraphicFramePr>
          <p:xfrm>
            <a:off x="288071" y="932144"/>
            <a:ext cx="3060000" cy="20542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1377184" y="262524"/>
              <a:ext cx="12212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FH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87" name="차트 18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1607779"/>
                </p:ext>
              </p:extLst>
            </p:nvPr>
          </p:nvGraphicFramePr>
          <p:xfrm>
            <a:off x="3443798" y="932144"/>
            <a:ext cx="3060700" cy="20542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90" name="TextBox 189"/>
            <p:cNvSpPr txBox="1"/>
            <p:nvPr/>
          </p:nvSpPr>
          <p:spPr>
            <a:xfrm>
              <a:off x="4578381" y="262524"/>
              <a:ext cx="11913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HL-1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88" name="차트 18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3592560"/>
                </p:ext>
              </p:extLst>
            </p:nvPr>
          </p:nvGraphicFramePr>
          <p:xfrm>
            <a:off x="288071" y="3902160"/>
            <a:ext cx="3060000" cy="205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91" name="TextBox 190"/>
            <p:cNvSpPr txBox="1"/>
            <p:nvPr/>
          </p:nvSpPr>
          <p:spPr>
            <a:xfrm>
              <a:off x="1327082" y="3220781"/>
              <a:ext cx="1256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59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93" name="차트 19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47761948"/>
                </p:ext>
              </p:extLst>
            </p:nvPr>
          </p:nvGraphicFramePr>
          <p:xfrm>
            <a:off x="3593122" y="3902160"/>
            <a:ext cx="3060000" cy="205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94" name="TextBox 193"/>
            <p:cNvSpPr txBox="1"/>
            <p:nvPr/>
          </p:nvSpPr>
          <p:spPr>
            <a:xfrm>
              <a:off x="4630641" y="3220781"/>
              <a:ext cx="12613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55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95" name="차트 19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79152253"/>
                </p:ext>
              </p:extLst>
            </p:nvPr>
          </p:nvGraphicFramePr>
          <p:xfrm>
            <a:off x="288070" y="6867859"/>
            <a:ext cx="3060000" cy="205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96" name="TextBox 195"/>
            <p:cNvSpPr txBox="1"/>
            <p:nvPr/>
          </p:nvSpPr>
          <p:spPr>
            <a:xfrm>
              <a:off x="1377184" y="6192172"/>
              <a:ext cx="12212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6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97" name="차트 19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5856862"/>
                </p:ext>
              </p:extLst>
            </p:nvPr>
          </p:nvGraphicFramePr>
          <p:xfrm>
            <a:off x="3341632" y="6867859"/>
            <a:ext cx="3060000" cy="2055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04" name="TextBox 203"/>
            <p:cNvSpPr txBox="1"/>
            <p:nvPr/>
          </p:nvSpPr>
          <p:spPr>
            <a:xfrm>
              <a:off x="4566362" y="6192172"/>
              <a:ext cx="11376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5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" name="그룹 22"/>
            <p:cNvGrpSpPr/>
            <p:nvPr/>
          </p:nvGrpSpPr>
          <p:grpSpPr>
            <a:xfrm>
              <a:off x="1377461" y="895522"/>
              <a:ext cx="1224454" cy="75977"/>
              <a:chOff x="1379525" y="1036620"/>
              <a:chExt cx="1224454" cy="75977"/>
            </a:xfrm>
          </p:grpSpPr>
          <p:cxnSp>
            <p:nvCxnSpPr>
              <p:cNvPr id="4" name="직선 연결선 3"/>
              <p:cNvCxnSpPr/>
              <p:nvPr/>
            </p:nvCxnSpPr>
            <p:spPr>
              <a:xfrm flipV="1">
                <a:off x="1379525" y="1036620"/>
                <a:ext cx="0" cy="756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" name="직선 연결선 5"/>
              <p:cNvCxnSpPr/>
              <p:nvPr/>
            </p:nvCxnSpPr>
            <p:spPr>
              <a:xfrm flipV="1">
                <a:off x="2600485" y="1040597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직선 연결선 7"/>
              <p:cNvCxnSpPr/>
              <p:nvPr/>
            </p:nvCxnSpPr>
            <p:spPr>
              <a:xfrm>
                <a:off x="1379979" y="1039812"/>
                <a:ext cx="122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그룹 41"/>
            <p:cNvGrpSpPr/>
            <p:nvPr/>
          </p:nvGrpSpPr>
          <p:grpSpPr>
            <a:xfrm>
              <a:off x="4578380" y="897511"/>
              <a:ext cx="1195200" cy="75977"/>
              <a:chOff x="1409093" y="1039796"/>
              <a:chExt cx="1195200" cy="75977"/>
            </a:xfrm>
          </p:grpSpPr>
          <p:cxnSp>
            <p:nvCxnSpPr>
              <p:cNvPr id="43" name="직선 연결선 42"/>
              <p:cNvCxnSpPr/>
              <p:nvPr/>
            </p:nvCxnSpPr>
            <p:spPr>
              <a:xfrm flipV="1">
                <a:off x="1410698" y="1039796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직선 연결선 43"/>
              <p:cNvCxnSpPr/>
              <p:nvPr/>
            </p:nvCxnSpPr>
            <p:spPr>
              <a:xfrm flipV="1">
                <a:off x="2600485" y="1043773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직선 연결선 44"/>
              <p:cNvCxnSpPr/>
              <p:nvPr/>
            </p:nvCxnSpPr>
            <p:spPr>
              <a:xfrm>
                <a:off x="1409093" y="1041400"/>
                <a:ext cx="1195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그룹 47"/>
            <p:cNvGrpSpPr/>
            <p:nvPr/>
          </p:nvGrpSpPr>
          <p:grpSpPr>
            <a:xfrm>
              <a:off x="1327081" y="3869174"/>
              <a:ext cx="1257774" cy="76322"/>
              <a:chOff x="1329265" y="1038224"/>
              <a:chExt cx="1257774" cy="76322"/>
            </a:xfrm>
          </p:grpSpPr>
          <p:cxnSp>
            <p:nvCxnSpPr>
              <p:cNvPr id="50" name="직선 연결선 49"/>
              <p:cNvCxnSpPr/>
              <p:nvPr/>
            </p:nvCxnSpPr>
            <p:spPr>
              <a:xfrm flipV="1">
                <a:off x="1329266" y="1038224"/>
                <a:ext cx="0" cy="756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직선 연결선 50"/>
              <p:cNvCxnSpPr/>
              <p:nvPr/>
            </p:nvCxnSpPr>
            <p:spPr>
              <a:xfrm flipV="1">
                <a:off x="2587039" y="1038946"/>
                <a:ext cx="0" cy="756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직선 연결선 51"/>
              <p:cNvCxnSpPr/>
              <p:nvPr/>
            </p:nvCxnSpPr>
            <p:spPr>
              <a:xfrm>
                <a:off x="1329265" y="1041400"/>
                <a:ext cx="12564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그룹 53"/>
            <p:cNvGrpSpPr/>
            <p:nvPr/>
          </p:nvGrpSpPr>
          <p:grpSpPr>
            <a:xfrm>
              <a:off x="4630640" y="3873771"/>
              <a:ext cx="1263600" cy="72785"/>
              <a:chOff x="1325969" y="1041400"/>
              <a:chExt cx="1263600" cy="72785"/>
            </a:xfrm>
          </p:grpSpPr>
          <p:cxnSp>
            <p:nvCxnSpPr>
              <p:cNvPr id="55" name="직선 연결선 54"/>
              <p:cNvCxnSpPr/>
              <p:nvPr/>
            </p:nvCxnSpPr>
            <p:spPr>
              <a:xfrm flipV="1">
                <a:off x="1329266" y="104140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직선 연결선 55"/>
              <p:cNvCxnSpPr/>
              <p:nvPr/>
            </p:nvCxnSpPr>
            <p:spPr>
              <a:xfrm flipV="1">
                <a:off x="2587301" y="1042185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/>
              <p:cNvCxnSpPr/>
              <p:nvPr/>
            </p:nvCxnSpPr>
            <p:spPr>
              <a:xfrm>
                <a:off x="1325969" y="1041400"/>
                <a:ext cx="1263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8" name="그룹 57"/>
            <p:cNvGrpSpPr/>
            <p:nvPr/>
          </p:nvGrpSpPr>
          <p:grpSpPr>
            <a:xfrm>
              <a:off x="1377184" y="6828257"/>
              <a:ext cx="1224000" cy="72785"/>
              <a:chOff x="1329265" y="1038224"/>
              <a:chExt cx="1224000" cy="72785"/>
            </a:xfrm>
          </p:grpSpPr>
          <p:cxnSp>
            <p:nvCxnSpPr>
              <p:cNvPr id="59" name="직선 연결선 58"/>
              <p:cNvCxnSpPr/>
              <p:nvPr/>
            </p:nvCxnSpPr>
            <p:spPr>
              <a:xfrm flipV="1">
                <a:off x="1329266" y="1038224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직선 연결선 59"/>
              <p:cNvCxnSpPr/>
              <p:nvPr/>
            </p:nvCxnSpPr>
            <p:spPr>
              <a:xfrm flipV="1">
                <a:off x="2550610" y="1039009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연결선 60"/>
              <p:cNvCxnSpPr/>
              <p:nvPr/>
            </p:nvCxnSpPr>
            <p:spPr>
              <a:xfrm>
                <a:off x="1329265" y="1041400"/>
                <a:ext cx="122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" name="그룹 62"/>
            <p:cNvGrpSpPr/>
            <p:nvPr/>
          </p:nvGrpSpPr>
          <p:grpSpPr>
            <a:xfrm>
              <a:off x="4562196" y="6827762"/>
              <a:ext cx="1137665" cy="75979"/>
              <a:chOff x="1414533" y="1037421"/>
              <a:chExt cx="1137665" cy="75979"/>
            </a:xfrm>
          </p:grpSpPr>
          <p:cxnSp>
            <p:nvCxnSpPr>
              <p:cNvPr id="64" name="직선 연결선 63"/>
              <p:cNvCxnSpPr/>
              <p:nvPr/>
            </p:nvCxnSpPr>
            <p:spPr>
              <a:xfrm flipV="1">
                <a:off x="1418699" y="1041400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직선 연결선 64"/>
              <p:cNvCxnSpPr/>
              <p:nvPr/>
            </p:nvCxnSpPr>
            <p:spPr>
              <a:xfrm flipV="1">
                <a:off x="2552198" y="1037421"/>
                <a:ext cx="0" cy="7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직선 연결선 65"/>
              <p:cNvCxnSpPr/>
              <p:nvPr/>
            </p:nvCxnSpPr>
            <p:spPr>
              <a:xfrm>
                <a:off x="1414533" y="1041400"/>
                <a:ext cx="11376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37"/>
            <p:cNvSpPr txBox="1"/>
            <p:nvPr/>
          </p:nvSpPr>
          <p:spPr>
            <a:xfrm>
              <a:off x="1377184" y="634731"/>
              <a:ext cx="12212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578381" y="636491"/>
              <a:ext cx="1191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327081" y="3604125"/>
              <a:ext cx="12563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634555" y="3611426"/>
              <a:ext cx="125639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377210" y="6564242"/>
              <a:ext cx="12172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562197" y="6568628"/>
              <a:ext cx="11417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5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92802" y="148837"/>
            <a:ext cx="2706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60548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52" y="3332996"/>
            <a:ext cx="3349156" cy="169777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127229"/>
            <a:ext cx="2706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7673" y="916295"/>
            <a:ext cx="25880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BSC-PCR for SOCS1 and SOCS3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7673" y="2889299"/>
            <a:ext cx="38319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 SOCS1 and SOCS3 expression under AZA treatment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9222295"/>
              </p:ext>
            </p:extLst>
          </p:nvPr>
        </p:nvGraphicFramePr>
        <p:xfrm>
          <a:off x="492252" y="1406377"/>
          <a:ext cx="2641600" cy="1079500"/>
        </p:xfrm>
        <a:graphic>
          <a:graphicData uri="http://schemas.openxmlformats.org/drawingml/2006/table">
            <a:tbl>
              <a:tblPr/>
              <a:tblGrid>
                <a:gridCol w="794007">
                  <a:extLst>
                    <a:ext uri="{9D8B030D-6E8A-4147-A177-3AD203B41FA5}">
                      <a16:colId xmlns:a16="http://schemas.microsoft.com/office/drawing/2014/main" val="2084417758"/>
                    </a:ext>
                  </a:extLst>
                </a:gridCol>
                <a:gridCol w="794007">
                  <a:extLst>
                    <a:ext uri="{9D8B030D-6E8A-4147-A177-3AD203B41FA5}">
                      <a16:colId xmlns:a16="http://schemas.microsoft.com/office/drawing/2014/main" val="2049289631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67451722"/>
                    </a:ext>
                  </a:extLst>
                </a:gridCol>
                <a:gridCol w="526793">
                  <a:extLst>
                    <a:ext uri="{9D8B030D-6E8A-4147-A177-3AD203B41FA5}">
                      <a16:colId xmlns:a16="http://schemas.microsoft.com/office/drawing/2014/main" val="3839324575"/>
                    </a:ext>
                  </a:extLst>
                </a:gridCol>
              </a:tblGrid>
              <a:tr h="2159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Gen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# of CpG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# of clon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7891496"/>
                  </a:ext>
                </a:extLst>
              </a:tr>
              <a:tr h="215900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A549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L13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5422500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OCS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3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1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6250702"/>
                  </a:ext>
                </a:extLst>
              </a:tr>
              <a:tr h="2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SOCS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53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0" i="0" u="none" strike="noStrike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20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4923964"/>
                  </a:ext>
                </a:extLst>
              </a:tr>
              <a:tr h="215900">
                <a:tc gridSpan="3"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No methylated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CpG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맑은 고딕" panose="020B0503020000020004" pitchFamily="50" charset="-127"/>
                          <a:ea typeface="맑은 고딕" panose="020B0503020000020004" pitchFamily="50" charset="-127"/>
                        </a:rPr>
                        <a:t> foun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31533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34048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7</TotalTime>
  <Words>55</Words>
  <Application>Microsoft Office PowerPoint</Application>
  <PresentationFormat>A4 용지(210x297mm)</PresentationFormat>
  <Paragraphs>30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</dc:creator>
  <cp:lastModifiedBy>Lee</cp:lastModifiedBy>
  <cp:revision>20</cp:revision>
  <dcterms:created xsi:type="dcterms:W3CDTF">2019-01-19T00:27:50Z</dcterms:created>
  <dcterms:modified xsi:type="dcterms:W3CDTF">2019-04-03T05:59:39Z</dcterms:modified>
</cp:coreProperties>
</file>